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5" r:id="rId2"/>
  </p:sldIdLst>
  <p:sldSz cx="6492875" cy="7864475"/>
  <p:notesSz cx="6669088" cy="9775825"/>
  <p:defaultTextStyle>
    <a:defPPr>
      <a:defRPr lang="de-DE"/>
    </a:defPPr>
    <a:lvl1pPr marL="0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77" userDrawn="1">
          <p15:clr>
            <a:srgbClr val="A4A3A4"/>
          </p15:clr>
        </p15:guide>
        <p15:guide id="2" pos="204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Krueger" initials="TK" lastIdx="3" clrIdx="0"/>
  <p:cmAuthor id="1" name="Office" initials="O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6F664"/>
    <a:srgbClr val="FACE60"/>
    <a:srgbClr val="065A06"/>
    <a:srgbClr val="37441C"/>
    <a:srgbClr val="ADA36F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8757" autoAdjust="0"/>
  </p:normalViewPr>
  <p:slideViewPr>
    <p:cSldViewPr>
      <p:cViewPr varScale="1">
        <p:scale>
          <a:sx n="57" d="100"/>
          <a:sy n="57" d="100"/>
        </p:scale>
        <p:origin x="2188" y="32"/>
      </p:cViewPr>
      <p:guideLst>
        <p:guide orient="horz" pos="2477"/>
        <p:guide pos="2045"/>
      </p:guideLst>
    </p:cSldViewPr>
  </p:slideViewPr>
  <p:notesTextViewPr>
    <p:cViewPr>
      <p:scale>
        <a:sx n="33" d="100"/>
        <a:sy n="33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CF3C3B8-13C0-45C6-9FFF-BCFBEA449F5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9D8228-2921-4AB0-8D46-F38DF75D06B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77825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BF47BF-6011-4EE6-A456-E4C5ECC88D20}" type="datetimeFigureOut">
              <a:rPr lang="en-US" smtClean="0"/>
              <a:t>02/0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C20D87-F40E-47F4-ABF9-4ED4F9BD995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841192-45A2-4783-A9D2-D9EC8A13F279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77825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434FD3-F380-421D-90B4-A8E7D6ECC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88755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7245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r">
              <a:defRPr sz="1100"/>
            </a:lvl1pPr>
          </a:lstStyle>
          <a:p>
            <a:fld id="{AC1B7B2B-A260-417A-BF54-29F76BDEF745}" type="datetimeFigureOut">
              <a:rPr lang="de-DE" smtClean="0"/>
              <a:pPr/>
              <a:t>06.02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820863" y="733425"/>
            <a:ext cx="3027362" cy="36655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4320" tIns="42160" rIns="84320" bIns="4216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7454" y="4644136"/>
            <a:ext cx="5334181" cy="4398813"/>
          </a:xfrm>
          <a:prstGeom prst="rect">
            <a:avLst/>
          </a:prstGeom>
        </p:spPr>
        <p:txBody>
          <a:bodyPr vert="horz" lIns="84320" tIns="42160" rIns="84320" bIns="4216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7245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r">
              <a:defRPr sz="1100"/>
            </a:lvl1pPr>
          </a:lstStyle>
          <a:p>
            <a:fld id="{0C4681C7-5AE4-4C4B-9445-68AE67E38C7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0574514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24474" y="1840032"/>
            <a:ext cx="5843247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24474" y="4222237"/>
            <a:ext cx="5843247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24473" y="1840032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318694" y="1840032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318694" y="4222237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24473" y="4222237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24474" y="1840031"/>
            <a:ext cx="5843247" cy="456091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24474" y="1840031"/>
            <a:ext cx="5843247" cy="456091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4" name="Grafik 3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24474" y="2165851"/>
            <a:ext cx="5843247" cy="3909278"/>
          </a:xfrm>
          <a:prstGeom prst="rect">
            <a:avLst/>
          </a:prstGeom>
          <a:ln>
            <a:noFill/>
          </a:ln>
        </p:spPr>
      </p:pic>
      <p:pic>
        <p:nvPicPr>
          <p:cNvPr id="35" name="Grafik 3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24474" y="2165851"/>
            <a:ext cx="5843247" cy="3909278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24474" y="1840031"/>
            <a:ext cx="5843247" cy="4561205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24474" y="1840031"/>
            <a:ext cx="5843247" cy="456091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24473" y="1840031"/>
            <a:ext cx="2851412" cy="456091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318694" y="1840031"/>
            <a:ext cx="2851412" cy="456091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24474" y="313532"/>
            <a:ext cx="5843247" cy="6087704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24473" y="1840032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24473" y="4222237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318694" y="1840031"/>
            <a:ext cx="2851412" cy="456091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24473" y="1840031"/>
            <a:ext cx="2851412" cy="456091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318694" y="1840032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318694" y="4222237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24474" y="313531"/>
            <a:ext cx="5843247" cy="131328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24473" y="1840032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318694" y="1840032"/>
            <a:ext cx="2851412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24474" y="4222237"/>
            <a:ext cx="5843247" cy="2175282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24474" y="313533"/>
            <a:ext cx="5843247" cy="1313001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3588">
                <a:latin typeface="Arial"/>
              </a:rPr>
              <a:t>Click to edit the title text format</a:t>
            </a:r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24474" y="1840031"/>
            <a:ext cx="5843247" cy="4560919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2609">
                <a:latin typeface="Arial"/>
              </a:rPr>
              <a:t>Click to edit the outline text format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283">
                <a:latin typeface="Arial"/>
              </a:rPr>
              <a:t>Second Outline Level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1956">
                <a:latin typeface="Arial"/>
              </a:rPr>
              <a:t>Third Outline Level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1630">
                <a:latin typeface="Arial"/>
              </a:rPr>
              <a:t>Fourth Outline Level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Fifth Outline Level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ixth Outline Level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eventh Outline Level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dt="0"/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A7A95105-6649-45A1-89E2-34DBFA53A8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2754769"/>
              </p:ext>
            </p:extLst>
          </p:nvPr>
        </p:nvGraphicFramePr>
        <p:xfrm>
          <a:off x="241449" y="503337"/>
          <a:ext cx="5976664" cy="7008547"/>
        </p:xfrm>
        <a:graphic>
          <a:graphicData uri="http://schemas.openxmlformats.org/drawingml/2006/table">
            <a:tbl>
              <a:tblPr firstRow="1" firstCol="1" bandRow="1"/>
              <a:tblGrid>
                <a:gridCol w="864096">
                  <a:extLst>
                    <a:ext uri="{9D8B030D-6E8A-4147-A177-3AD203B41FA5}">
                      <a16:colId xmlns:a16="http://schemas.microsoft.com/office/drawing/2014/main" val="457693918"/>
                    </a:ext>
                  </a:extLst>
                </a:gridCol>
                <a:gridCol w="2995344">
                  <a:extLst>
                    <a:ext uri="{9D8B030D-6E8A-4147-A177-3AD203B41FA5}">
                      <a16:colId xmlns:a16="http://schemas.microsoft.com/office/drawing/2014/main" val="3149766506"/>
                    </a:ext>
                  </a:extLst>
                </a:gridCol>
                <a:gridCol w="530640">
                  <a:extLst>
                    <a:ext uri="{9D8B030D-6E8A-4147-A177-3AD203B41FA5}">
                      <a16:colId xmlns:a16="http://schemas.microsoft.com/office/drawing/2014/main" val="203044301"/>
                    </a:ext>
                  </a:extLst>
                </a:gridCol>
                <a:gridCol w="486420">
                  <a:extLst>
                    <a:ext uri="{9D8B030D-6E8A-4147-A177-3AD203B41FA5}">
                      <a16:colId xmlns:a16="http://schemas.microsoft.com/office/drawing/2014/main" val="4072783330"/>
                    </a:ext>
                  </a:extLst>
                </a:gridCol>
                <a:gridCol w="1100164">
                  <a:extLst>
                    <a:ext uri="{9D8B030D-6E8A-4147-A177-3AD203B41FA5}">
                      <a16:colId xmlns:a16="http://schemas.microsoft.com/office/drawing/2014/main" val="3543778318"/>
                    </a:ext>
                  </a:extLst>
                </a:gridCol>
              </a:tblGrid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. fumigatus 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293 protein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rtholog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erag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dentity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cession No.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727025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FgnA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749851.1﻿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494_02599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seudogymnoascus sp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. VKM F-4513 (FW-928)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7.48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FY42107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5030723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MCG_07466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Valsa malicola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65.8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OV97139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006390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lovastatin </a:t>
                      </a:r>
                      <a:r>
                        <a:rPr lang="en-US" sz="800" dirty="0" err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nonaketide</a:t>
                      </a: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synthase [</a:t>
                      </a:r>
                      <a:r>
                        <a:rPr lang="en-US" sz="800" i="1" dirty="0" err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Escovopsis</a:t>
                      </a:r>
                      <a:r>
                        <a:rPr lang="en-US" sz="800" i="1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dirty="0" err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weber</a:t>
                      </a:r>
                      <a:r>
                        <a:rPr lang="en-US" sz="800" dirty="0" err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64.42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OS21700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9658000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SNOG_13032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arastagonospora nodorum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SN15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8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75.24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001803246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3170765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M426DRAFT_269167 [Hypoxylon sp. CI-4A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60.4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TA99530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5240738"/>
                  </a:ext>
                </a:extLst>
              </a:tr>
              <a:tr h="12430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utative polyketide synthase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ylona heveae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TC161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52.36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 spc="-3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0181896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2059726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fu1g01000</a:t>
                      </a: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MCG_07467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Valsa malicola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8.87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OV97138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3419010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749850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494_02600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seudogymnoascus sp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. VKM F-4513 (FW-928)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5.4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FY42096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9284015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SNOG_13033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arastagonospora nodorum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SN15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6.04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001803247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7272739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M426DRAFT_67657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xylon sp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. CI-4A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1.5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TA99529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3636057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gibberellin 20 oxidase 1-A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Escovopsis weberi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6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7.73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OS21699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1574360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xidoreductase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ylona heveae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TC161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2.0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0181893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8553620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COCC4DRAFT_155115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Bipolaris maydis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ATCC 48331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88.17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014072629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9079646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ts val="11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fu1g00990</a:t>
                      </a:r>
                      <a:r>
                        <a:rPr kumimoji="0" lang="en-US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n-US" sz="8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749849.1</a:t>
                      </a:r>
                      <a:endParaRPr kumimoji="0" lang="en-U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SNOG_13034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arastagonospora nodorum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SN15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85.5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001803248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3965559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MCG_07468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Valsa malicola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7.9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OV97136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9151081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494_02601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seudogymnoascus sp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. VKM F-4513 (FW-928)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7.6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FY42097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2898878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M426DRAFT_325059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xylon sp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. CI-4A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5.1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TA99528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0181499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dehydrogenase/reductase SDR family member 11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Escovopsis weberi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5.67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OS21698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5781209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M434DRAFT_19274 [Hypoxylon sp. CO27-5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6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0.04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TA97075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2649946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fu1g00980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749848.1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494_02602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seudogymnoascus sp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. VKM F-4513 (FW-928)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3.4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FY42098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8388070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glucooligosaccharide oxidase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xylon sp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. EC38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3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0.28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TA68786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7555611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MCG_07469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Valsa malicola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86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2.23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OV97135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4576141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-hydroxy-D-nicotine oxidase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Escovopsis weberi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49.0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OS21702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8170508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SNOG_13035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arastagonospora nodorum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SN15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8.18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001803249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976339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M434DRAFT_66240 [Hypoxylon sp. CO27-5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4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7.14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TA97076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635572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fu1g00970</a:t>
                      </a:r>
                    </a:p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749847.1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494_02603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seudogymnoascus sp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. VKM F-4513 (FW-928)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6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70.24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FY42099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9096091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iboflavin transporter MCH5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Escovopsis weberi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2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3.5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OS21697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2590700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  <a:tabLst>
                          <a:tab pos="1896745" algn="l"/>
                        </a:tabLs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iboflavin transporter MCH5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Valsa mali var. pyri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4.2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KUI57826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3502840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major facilitator superfamily transporter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Colletotrichum gloeosporioides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Cg-14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2.02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EQB49150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8103856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utative MFS monocarboxylate transporter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Coniochaeta ligniaria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NRRL 30616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3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1.79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IW35691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595708"/>
                  </a:ext>
                </a:extLst>
              </a:tr>
              <a:tr h="108093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VMCG_08563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Valsa malicola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5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3.1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OV95205.1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8809550"/>
                  </a:ext>
                </a:extLst>
              </a:tr>
              <a:tr h="216187"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ypothetical protein SNOG_13036 [</a:t>
                      </a:r>
                      <a:r>
                        <a:rPr lang="en-US" sz="800" i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arastagonospora nodorum</a:t>
                      </a: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SN15]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60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80.52</a:t>
                      </a:r>
                      <a:endParaRPr lang="en-US" sz="9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1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XP_001803250.1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064" marR="530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0189856"/>
                  </a:ext>
                </a:extLst>
              </a:tr>
            </a:tbl>
          </a:graphicData>
        </a:graphic>
      </p:graphicFrame>
      <p:sp>
        <p:nvSpPr>
          <p:cNvPr id="4" name="Textfeld 24">
            <a:extLst>
              <a:ext uri="{FF2B5EF4-FFF2-40B4-BE49-F238E27FC236}">
                <a16:creationId xmlns:a16="http://schemas.microsoft.com/office/drawing/2014/main" id="{87B7A165-B6A7-45EC-8874-43E938111F25}"/>
              </a:ext>
            </a:extLst>
          </p:cNvPr>
          <p:cNvSpPr txBox="1"/>
          <p:nvPr/>
        </p:nvSpPr>
        <p:spPr>
          <a:xfrm>
            <a:off x="2242375" y="43805"/>
            <a:ext cx="18165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le 5</a:t>
            </a:r>
          </a:p>
        </p:txBody>
      </p:sp>
    </p:spTree>
    <p:extLst>
      <p:ext uri="{BB962C8B-B14F-4D97-AF65-F5344CB8AC3E}">
        <p14:creationId xmlns:p14="http://schemas.microsoft.com/office/powerpoint/2010/main" val="1853562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3</TotalTime>
  <Words>485</Words>
  <Application>Microsoft Office PowerPoint</Application>
  <PresentationFormat>Custom</PresentationFormat>
  <Paragraphs>17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tar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a Stroe</dc:creator>
  <cp:lastModifiedBy>Maria</cp:lastModifiedBy>
  <cp:revision>1463</cp:revision>
  <cp:lastPrinted>2019-03-07T13:16:11Z</cp:lastPrinted>
  <dcterms:modified xsi:type="dcterms:W3CDTF">2020-02-06T20:23:57Z</dcterms:modified>
</cp:coreProperties>
</file>